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85487-20CC-4C27-8D13-524EBBE50A4A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5E41E-167C-4241-ADE4-A3F082618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674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85487-20CC-4C27-8D13-524EBBE50A4A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5E41E-167C-4241-ADE4-A3F082618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4644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85487-20CC-4C27-8D13-524EBBE50A4A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5E41E-167C-4241-ADE4-A3F082618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044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85487-20CC-4C27-8D13-524EBBE50A4A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5E41E-167C-4241-ADE4-A3F082618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062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85487-20CC-4C27-8D13-524EBBE50A4A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5E41E-167C-4241-ADE4-A3F082618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64477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85487-20CC-4C27-8D13-524EBBE50A4A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5E41E-167C-4241-ADE4-A3F082618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0677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85487-20CC-4C27-8D13-524EBBE50A4A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5E41E-167C-4241-ADE4-A3F082618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652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85487-20CC-4C27-8D13-524EBBE50A4A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5E41E-167C-4241-ADE4-A3F082618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5800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85487-20CC-4C27-8D13-524EBBE50A4A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5E41E-167C-4241-ADE4-A3F082618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97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85487-20CC-4C27-8D13-524EBBE50A4A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5E41E-167C-4241-ADE4-A3F082618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7111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485487-20CC-4C27-8D13-524EBBE50A4A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25E41E-167C-4241-ADE4-A3F082618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0744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485487-20CC-4C27-8D13-524EBBE50A4A}" type="datetimeFigureOut">
              <a:rPr lang="en-US" smtClean="0"/>
              <a:t>7/7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25E41E-167C-4241-ADE4-A3F0826181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96279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3" Type="http://schemas.microsoft.com/office/2007/relationships/hdphoto" Target="../media/hdphoto1.wdp"/><Relationship Id="rId21" Type="http://schemas.microsoft.com/office/2007/relationships/hdphoto" Target="../media/hdphoto10.wdp"/><Relationship Id="rId7" Type="http://schemas.microsoft.com/office/2007/relationships/hdphoto" Target="../media/hdphoto3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microsoft.com/office/2007/relationships/hdphoto" Target="../media/hdphoto7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hdphoto" Target="../media/hdphoto11.wdp"/><Relationship Id="rId7" Type="http://schemas.microsoft.com/office/2007/relationships/hdphoto" Target="../media/hdphoto13.wdp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microsoft.com/office/2007/relationships/hdphoto" Target="../media/hdphoto12.wdp"/><Relationship Id="rId4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microsoft.com/office/2007/relationships/hdphoto" Target="../media/hdphoto14.wdp"/><Relationship Id="rId7" Type="http://schemas.microsoft.com/office/2007/relationships/hdphoto" Target="../media/hdphoto16.wdp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5" Type="http://schemas.microsoft.com/office/2007/relationships/hdphoto" Target="../media/hdphoto15.wdp"/><Relationship Id="rId4" Type="http://schemas.openxmlformats.org/officeDocument/2006/relationships/image" Target="../media/image15.png"/><Relationship Id="rId9" Type="http://schemas.microsoft.com/office/2007/relationships/hdphoto" Target="../media/hdphoto17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576095" y="238921"/>
            <a:ext cx="507192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Cont</a:t>
            </a:r>
            <a:endParaRPr lang="en-US" sz="9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1999685" y="247487"/>
            <a:ext cx="424046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Eth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350754" y="256053"/>
            <a:ext cx="717037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Eth+SSA</a:t>
            </a:r>
            <a:endParaRPr lang="en-US" sz="9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2828172" y="238921"/>
            <a:ext cx="449781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SS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3179429" y="247487"/>
            <a:ext cx="445822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kda</a:t>
            </a:r>
            <a:endParaRPr lang="en-US" sz="900" b="1" dirty="0"/>
          </a:p>
        </p:txBody>
      </p:sp>
      <p:sp>
        <p:nvSpPr>
          <p:cNvPr id="7" name="Rectangle 6"/>
          <p:cNvSpPr/>
          <p:nvPr/>
        </p:nvSpPr>
        <p:spPr>
          <a:xfrm>
            <a:off x="1928029" y="0"/>
            <a:ext cx="1166422" cy="3325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Hippocampus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1388178" y="256053"/>
            <a:ext cx="1762577" cy="1421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866827" y="204034"/>
            <a:ext cx="507192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Cont</a:t>
            </a:r>
            <a:endParaRPr lang="en-US" sz="900" b="1" dirty="0"/>
          </a:p>
        </p:txBody>
      </p:sp>
      <p:sp>
        <p:nvSpPr>
          <p:cNvPr id="10" name="TextBox 9"/>
          <p:cNvSpPr txBox="1"/>
          <p:nvPr/>
        </p:nvSpPr>
        <p:spPr>
          <a:xfrm>
            <a:off x="5411485" y="204034"/>
            <a:ext cx="424046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Eth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766645" y="204034"/>
            <a:ext cx="717037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Eth+SSA</a:t>
            </a:r>
            <a:endParaRPr lang="en-US" sz="9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6336302" y="204034"/>
            <a:ext cx="449781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SS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667521" y="204034"/>
            <a:ext cx="445822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kda</a:t>
            </a:r>
            <a:endParaRPr lang="en-US" sz="900" b="1" dirty="0"/>
          </a:p>
        </p:txBody>
      </p:sp>
      <p:sp>
        <p:nvSpPr>
          <p:cNvPr id="14" name="Rectangle 13"/>
          <p:cNvSpPr/>
          <p:nvPr/>
        </p:nvSpPr>
        <p:spPr>
          <a:xfrm>
            <a:off x="5436159" y="-34887"/>
            <a:ext cx="1166422" cy="3325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Hippocampus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5" name="Straight Connector 14"/>
          <p:cNvCxnSpPr/>
          <p:nvPr/>
        </p:nvCxnSpPr>
        <p:spPr>
          <a:xfrm flipV="1">
            <a:off x="4896308" y="221166"/>
            <a:ext cx="1762577" cy="1421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6" name="Picture 15"/>
          <p:cNvPicPr preferRelativeResize="0">
            <a:picLocks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0039" y="496077"/>
            <a:ext cx="1645920" cy="1463040"/>
          </a:xfrm>
          <a:prstGeom prst="rect">
            <a:avLst/>
          </a:prstGeom>
        </p:spPr>
      </p:pic>
      <p:pic>
        <p:nvPicPr>
          <p:cNvPr id="17" name="Picture 16"/>
          <p:cNvPicPr preferRelativeResize="0">
            <a:picLocks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75199" y="513445"/>
            <a:ext cx="1645920" cy="1463040"/>
          </a:xfrm>
          <a:prstGeom prst="rect">
            <a:avLst/>
          </a:prstGeom>
        </p:spPr>
      </p:pic>
      <p:pic>
        <p:nvPicPr>
          <p:cNvPr id="18" name="Picture 17"/>
          <p:cNvPicPr preferRelativeResize="0">
            <a:picLocks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66000"/>
                    </a14:imgEffect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0039" y="2065662"/>
            <a:ext cx="1645920" cy="146304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894338" y="621778"/>
            <a:ext cx="482509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TLR4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965996" y="2983006"/>
            <a:ext cx="525489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RAGE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970668" y="4087649"/>
            <a:ext cx="516146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GFAP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368550" y="717079"/>
            <a:ext cx="532964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P-JNK</a:t>
            </a:r>
          </a:p>
        </p:txBody>
      </p:sp>
      <p:pic>
        <p:nvPicPr>
          <p:cNvPr id="23" name="Picture 22"/>
          <p:cNvPicPr preferRelativeResize="0">
            <a:picLocks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0039" y="3635246"/>
            <a:ext cx="1645920" cy="1463040"/>
          </a:xfrm>
          <a:prstGeom prst="rect">
            <a:avLst/>
          </a:prstGeom>
        </p:spPr>
      </p:pic>
      <p:pic>
        <p:nvPicPr>
          <p:cNvPr id="24" name="Picture 23"/>
          <p:cNvPicPr preferRelativeResize="0">
            <a:picLocks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660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44775" y="5204830"/>
            <a:ext cx="1645920" cy="1463040"/>
          </a:xfrm>
          <a:prstGeom prst="rect">
            <a:avLst/>
          </a:prstGeom>
        </p:spPr>
      </p:pic>
      <p:pic>
        <p:nvPicPr>
          <p:cNvPr id="25" name="Picture 24"/>
          <p:cNvPicPr preferRelativeResize="0">
            <a:picLocks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5228" y="3656608"/>
            <a:ext cx="1645920" cy="1463040"/>
          </a:xfrm>
          <a:prstGeom prst="rect">
            <a:avLst/>
          </a:prstGeom>
        </p:spPr>
      </p:pic>
      <p:pic>
        <p:nvPicPr>
          <p:cNvPr id="26" name="Picture 25"/>
          <p:cNvPicPr preferRelativeResize="0">
            <a:picLocks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65228" y="2063823"/>
            <a:ext cx="1645920" cy="1463040"/>
          </a:xfrm>
          <a:prstGeom prst="rect">
            <a:avLst/>
          </a:prstGeom>
        </p:spPr>
      </p:pic>
      <p:pic>
        <p:nvPicPr>
          <p:cNvPr id="27" name="Picture 26"/>
          <p:cNvPicPr preferRelativeResize="0">
            <a:picLocks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3685" y="5249393"/>
            <a:ext cx="1645920" cy="1463040"/>
          </a:xfrm>
          <a:prstGeom prst="rect">
            <a:avLst/>
          </a:prstGeom>
        </p:spPr>
      </p:pic>
      <p:sp>
        <p:nvSpPr>
          <p:cNvPr id="28" name="TextBox 27"/>
          <p:cNvSpPr txBox="1"/>
          <p:nvPr/>
        </p:nvSpPr>
        <p:spPr>
          <a:xfrm>
            <a:off x="8473511" y="199050"/>
            <a:ext cx="507192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Cont</a:t>
            </a:r>
            <a:endParaRPr lang="en-US" sz="9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8913753" y="206970"/>
            <a:ext cx="424046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Eth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9268913" y="206970"/>
            <a:ext cx="717037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Eth+SSA</a:t>
            </a:r>
            <a:endParaRPr lang="en-US" sz="9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9838570" y="206970"/>
            <a:ext cx="449781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SSA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10169789" y="206970"/>
            <a:ext cx="445822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kda</a:t>
            </a:r>
            <a:endParaRPr lang="en-US" sz="900" b="1" dirty="0"/>
          </a:p>
        </p:txBody>
      </p:sp>
      <p:sp>
        <p:nvSpPr>
          <p:cNvPr id="33" name="Rectangle 32"/>
          <p:cNvSpPr/>
          <p:nvPr/>
        </p:nvSpPr>
        <p:spPr>
          <a:xfrm>
            <a:off x="8938427" y="-31951"/>
            <a:ext cx="1166422" cy="3325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Hippocampus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34" name="Straight Connector 33"/>
          <p:cNvCxnSpPr/>
          <p:nvPr/>
        </p:nvCxnSpPr>
        <p:spPr>
          <a:xfrm flipV="1">
            <a:off x="8398576" y="224102"/>
            <a:ext cx="1762577" cy="1421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35" name="Picture 34"/>
          <p:cNvPicPr preferRelativeResize="0">
            <a:picLocks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1111" y="2036746"/>
            <a:ext cx="1645920" cy="1463040"/>
          </a:xfrm>
          <a:prstGeom prst="rect">
            <a:avLst/>
          </a:prstGeom>
        </p:spPr>
      </p:pic>
      <p:pic>
        <p:nvPicPr>
          <p:cNvPr id="36" name="Picture 35"/>
          <p:cNvPicPr preferRelativeResize="0">
            <a:picLocks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441111" y="452367"/>
            <a:ext cx="1645920" cy="1463040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1025121" y="6051366"/>
            <a:ext cx="499326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Iba-1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4350536" y="2415325"/>
            <a:ext cx="624533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P-NFKB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4390664" y="6072740"/>
            <a:ext cx="488114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IL-1</a:t>
            </a:r>
            <a:r>
              <a:rPr lang="el-GR" sz="900" b="1" dirty="0"/>
              <a:t>β</a:t>
            </a:r>
            <a:endParaRPr lang="en-US" sz="9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4411743" y="4539559"/>
            <a:ext cx="4459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 smtClean="0"/>
              <a:t>Tnf</a:t>
            </a:r>
            <a:r>
              <a:rPr lang="en-US" sz="900" b="1" dirty="0" smtClean="0"/>
              <a:t>-</a:t>
            </a:r>
            <a:r>
              <a:rPr lang="el-GR" sz="900" b="1" dirty="0" smtClean="0"/>
              <a:t>α</a:t>
            </a:r>
            <a:endParaRPr lang="en-US" sz="900" b="1" dirty="0"/>
          </a:p>
        </p:txBody>
      </p:sp>
      <p:sp>
        <p:nvSpPr>
          <p:cNvPr id="41" name="TextBox 40"/>
          <p:cNvSpPr txBox="1"/>
          <p:nvPr/>
        </p:nvSpPr>
        <p:spPr>
          <a:xfrm>
            <a:off x="7968040" y="2760061"/>
            <a:ext cx="620795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b="1" dirty="0"/>
              <a:t>β</a:t>
            </a:r>
            <a:r>
              <a:rPr lang="en-US" sz="900" b="1" dirty="0"/>
              <a:t>-Actin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7968040" y="1033884"/>
            <a:ext cx="482509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IL-10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6794017" y="717079"/>
            <a:ext cx="349828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56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3299202" y="621778"/>
            <a:ext cx="349828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90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3225943" y="2993445"/>
            <a:ext cx="349828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50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3190695" y="4071647"/>
            <a:ext cx="34982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50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0240281" y="2752958"/>
            <a:ext cx="349828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43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3267396" y="6058517"/>
            <a:ext cx="349828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17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6726605" y="2443826"/>
            <a:ext cx="349828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65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6764609" y="6125125"/>
            <a:ext cx="349828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31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10197670" y="986904"/>
            <a:ext cx="349828" cy="19698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21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6751478" y="4539559"/>
            <a:ext cx="30008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17</a:t>
            </a:r>
            <a:endParaRPr lang="en-US" sz="900" b="1" dirty="0"/>
          </a:p>
        </p:txBody>
      </p:sp>
    </p:spTree>
    <p:extLst>
      <p:ext uri="{BB962C8B-B14F-4D97-AF65-F5344CB8AC3E}">
        <p14:creationId xmlns:p14="http://schemas.microsoft.com/office/powerpoint/2010/main" val="30274751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4295723" y="5653153"/>
            <a:ext cx="657647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b="1" dirty="0"/>
              <a:t>β</a:t>
            </a:r>
            <a:r>
              <a:rPr lang="en-US" sz="900" b="1" dirty="0"/>
              <a:t>-Actin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295723" y="1095603"/>
            <a:ext cx="538867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NRF2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226716" y="3432224"/>
            <a:ext cx="528968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HO-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908561" y="519497"/>
            <a:ext cx="507192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Cont</a:t>
            </a:r>
            <a:endParaRPr lang="en-US" sz="9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5336988" y="525019"/>
            <a:ext cx="424046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Eth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663008" y="519497"/>
            <a:ext cx="717037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Eth+SSA</a:t>
            </a:r>
            <a:endParaRPr lang="en-US" sz="900" b="1" dirty="0"/>
          </a:p>
        </p:txBody>
      </p:sp>
      <p:sp>
        <p:nvSpPr>
          <p:cNvPr id="11" name="TextBox 10"/>
          <p:cNvSpPr txBox="1"/>
          <p:nvPr/>
        </p:nvSpPr>
        <p:spPr>
          <a:xfrm>
            <a:off x="6188329" y="527887"/>
            <a:ext cx="449781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SS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500468" y="492837"/>
            <a:ext cx="445822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kda</a:t>
            </a:r>
            <a:endParaRPr lang="en-US" sz="9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6538612" y="5649249"/>
            <a:ext cx="3143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43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6538612" y="1076793"/>
            <a:ext cx="3748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110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6538612" y="3432224"/>
            <a:ext cx="31437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/>
              <a:t>34</a:t>
            </a:r>
          </a:p>
        </p:txBody>
      </p:sp>
      <p:sp>
        <p:nvSpPr>
          <p:cNvPr id="16" name="Rectangle 15"/>
          <p:cNvSpPr/>
          <p:nvPr/>
        </p:nvSpPr>
        <p:spPr>
          <a:xfrm>
            <a:off x="5269106" y="253916"/>
            <a:ext cx="1166422" cy="3325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Hippocampus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17" name="Straight Connector 16"/>
          <p:cNvCxnSpPr/>
          <p:nvPr/>
        </p:nvCxnSpPr>
        <p:spPr>
          <a:xfrm flipV="1">
            <a:off x="4862124" y="509969"/>
            <a:ext cx="1602343" cy="1421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19" name="Picture 18"/>
          <p:cNvPicPr preferRelativeResize="0">
            <a:picLocks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9908" y="2782001"/>
            <a:ext cx="1554480" cy="1828800"/>
          </a:xfrm>
          <a:prstGeom prst="rect">
            <a:avLst/>
          </a:prstGeom>
        </p:spPr>
      </p:pic>
      <p:pic>
        <p:nvPicPr>
          <p:cNvPr id="20" name="Picture 19"/>
          <p:cNvPicPr preferRelativeResize="0">
            <a:picLocks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69908" y="4750841"/>
            <a:ext cx="1554480" cy="1828800"/>
          </a:xfrm>
          <a:prstGeom prst="rect">
            <a:avLst/>
          </a:prstGeom>
        </p:spPr>
      </p:pic>
      <p:pic>
        <p:nvPicPr>
          <p:cNvPr id="21" name="Picture 20"/>
          <p:cNvPicPr preferRelativeResize="0">
            <a:picLocks/>
          </p:cNvPicPr>
          <p:nvPr/>
        </p:nvPicPr>
        <p:blipFill rotWithShape="1"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821"/>
          <a:stretch/>
        </p:blipFill>
        <p:spPr>
          <a:xfrm>
            <a:off x="4869908" y="813161"/>
            <a:ext cx="1554480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37510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890977" y="361235"/>
            <a:ext cx="507192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Cont</a:t>
            </a:r>
            <a:endParaRPr lang="en-US" sz="900" b="1" dirty="0"/>
          </a:p>
        </p:txBody>
      </p:sp>
      <p:sp>
        <p:nvSpPr>
          <p:cNvPr id="3" name="TextBox 2"/>
          <p:cNvSpPr txBox="1"/>
          <p:nvPr/>
        </p:nvSpPr>
        <p:spPr>
          <a:xfrm>
            <a:off x="5319404" y="366757"/>
            <a:ext cx="424046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Eth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5645424" y="361235"/>
            <a:ext cx="717037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Eth+SSA</a:t>
            </a:r>
            <a:endParaRPr lang="en-US" sz="9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6170745" y="369625"/>
            <a:ext cx="449781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SSA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482884" y="334575"/>
            <a:ext cx="445822" cy="2670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err="1"/>
              <a:t>kda</a:t>
            </a:r>
            <a:endParaRPr lang="en-US" sz="900" b="1" dirty="0"/>
          </a:p>
        </p:txBody>
      </p:sp>
      <p:sp>
        <p:nvSpPr>
          <p:cNvPr id="7" name="Rectangle 6"/>
          <p:cNvSpPr/>
          <p:nvPr/>
        </p:nvSpPr>
        <p:spPr>
          <a:xfrm>
            <a:off x="5251522" y="95654"/>
            <a:ext cx="1166422" cy="33255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000" b="1" dirty="0" smtClean="0">
                <a:latin typeface="Times New Roman" pitchFamily="18" charset="0"/>
                <a:cs typeface="Times New Roman" pitchFamily="18" charset="0"/>
              </a:rPr>
              <a:t>Hippocampus</a:t>
            </a:r>
            <a:endParaRPr lang="en-US" sz="10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 flipV="1">
            <a:off x="4844540" y="351707"/>
            <a:ext cx="1602343" cy="1421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pic>
        <p:nvPicPr>
          <p:cNvPr id="9" name="Picture 8"/>
          <p:cNvPicPr preferRelativeResize="0">
            <a:picLocks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2026" y="5353574"/>
            <a:ext cx="1645920" cy="1463040"/>
          </a:xfrm>
          <a:prstGeom prst="rect">
            <a:avLst/>
          </a:prstGeom>
        </p:spPr>
      </p:pic>
      <p:pic>
        <p:nvPicPr>
          <p:cNvPr id="10" name="Picture 9"/>
          <p:cNvPicPr preferRelativeResize="0">
            <a:picLocks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2026" y="601579"/>
            <a:ext cx="1645920" cy="1463040"/>
          </a:xfrm>
          <a:prstGeom prst="rect">
            <a:avLst/>
          </a:prstGeom>
        </p:spPr>
      </p:pic>
      <p:pic>
        <p:nvPicPr>
          <p:cNvPr id="11" name="Picture 10"/>
          <p:cNvPicPr preferRelativeResize="0">
            <a:picLocks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2026" y="2185577"/>
            <a:ext cx="1645920" cy="1463040"/>
          </a:xfrm>
          <a:prstGeom prst="rect">
            <a:avLst/>
          </a:prstGeom>
        </p:spPr>
      </p:pic>
      <p:pic>
        <p:nvPicPr>
          <p:cNvPr id="12" name="Picture 11"/>
          <p:cNvPicPr preferRelativeResize="0">
            <a:picLocks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22026" y="3769575"/>
            <a:ext cx="1645920" cy="146304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4321640" y="2337408"/>
            <a:ext cx="522900" cy="2522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PSD-95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247902" y="4628396"/>
            <a:ext cx="596638" cy="2522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SNAP-23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289954" y="5958962"/>
            <a:ext cx="532518" cy="2522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b="1" dirty="0"/>
              <a:t>β</a:t>
            </a:r>
            <a:r>
              <a:rPr lang="en-US" sz="900" b="1" dirty="0"/>
              <a:t>-Actin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4304381" y="1329587"/>
            <a:ext cx="503664" cy="2522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 smtClean="0"/>
              <a:t>P-</a:t>
            </a:r>
            <a:r>
              <a:rPr lang="en-US" sz="900" b="1" dirty="0" err="1" smtClean="0"/>
              <a:t>Creb</a:t>
            </a:r>
            <a:endParaRPr lang="en-US" sz="900" b="1" dirty="0"/>
          </a:p>
        </p:txBody>
      </p:sp>
      <p:sp>
        <p:nvSpPr>
          <p:cNvPr id="17" name="TextBox 16"/>
          <p:cNvSpPr txBox="1"/>
          <p:nvPr/>
        </p:nvSpPr>
        <p:spPr>
          <a:xfrm>
            <a:off x="6555578" y="2337409"/>
            <a:ext cx="300082" cy="2522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95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6562818" y="4642611"/>
            <a:ext cx="300082" cy="2522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23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562818" y="5979519"/>
            <a:ext cx="300082" cy="2522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43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6555578" y="1329587"/>
            <a:ext cx="300082" cy="2522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/>
              <a:t>43</a:t>
            </a:r>
          </a:p>
        </p:txBody>
      </p:sp>
    </p:spTree>
    <p:extLst>
      <p:ext uri="{BB962C8B-B14F-4D97-AF65-F5344CB8AC3E}">
        <p14:creationId xmlns:p14="http://schemas.microsoft.com/office/powerpoint/2010/main" val="27144859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69</Words>
  <Application>Microsoft Office PowerPoint</Application>
  <PresentationFormat>Widescreen</PresentationFormat>
  <Paragraphs>6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Company>hom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smail - [2010]</dc:creator>
  <cp:lastModifiedBy>ismail - [2010]</cp:lastModifiedBy>
  <cp:revision>6</cp:revision>
  <dcterms:created xsi:type="dcterms:W3CDTF">2025-04-16T09:25:01Z</dcterms:created>
  <dcterms:modified xsi:type="dcterms:W3CDTF">2025-07-07T08:07:42Z</dcterms:modified>
</cp:coreProperties>
</file>